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22BE0-E4C6-47E1-9120-7F6FA77648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1E4E3-CB15-4E1F-B72F-EA60297D70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A2A0BC-6ED0-4304-860F-F5B067AA59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ACF46-1744-46B2-ACAC-1D8035091E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38D593-86A5-4648-8325-703E7796BC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805C66-3B15-4139-9DA2-687B9B79FF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001B3-3721-4930-8169-3F17115F11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E95271-A9CF-49D3-8250-A568E32EF4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D9F0F1-27A9-44B2-9519-441356BB8D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DA772-9CAE-4917-8CC9-F7B06B7D7A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EF2039-AC1A-4B6B-8724-726859F94F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70B75F-86A6-41C6-BB64-99D67F12B0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3EEA1E-5196-4F1E-AA2C-9211D6B38CD6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641960" y="9539280"/>
            <a:ext cx="355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upplementary Figure 6 (Fig. S6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697040" y="3359880"/>
            <a:ext cx="3510000" cy="3508200"/>
            <a:chOff x="1697040" y="3359880"/>
            <a:chExt cx="3510000" cy="3508200"/>
          </a:xfrm>
        </p:grpSpPr>
        <p:pic>
          <p:nvPicPr>
            <p:cNvPr id="43" name="Picture 7" descr=""/>
            <p:cNvPicPr/>
            <p:nvPr/>
          </p:nvPicPr>
          <p:blipFill>
            <a:blip r:embed="rId1"/>
            <a:srcRect l="10608" t="7697" r="9407" b="25317"/>
            <a:stretch/>
          </p:blipFill>
          <p:spPr>
            <a:xfrm>
              <a:off x="2079720" y="5175360"/>
              <a:ext cx="1377720" cy="1285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3" descr=""/>
            <p:cNvPicPr/>
            <p:nvPr/>
          </p:nvPicPr>
          <p:blipFill>
            <a:blip r:embed="rId2"/>
            <a:srcRect l="9951" t="7902" r="8552" b="25511"/>
            <a:stretch/>
          </p:blipFill>
          <p:spPr>
            <a:xfrm>
              <a:off x="2081160" y="3606840"/>
              <a:ext cx="1374840" cy="128412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45" name="Gerade Verbindung mit Pfeil 5"/>
            <p:cNvCxnSpPr/>
            <p:nvPr/>
          </p:nvCxnSpPr>
          <p:spPr>
            <a:xfrm flipH="1" flipV="1">
              <a:off x="1975680" y="3359880"/>
              <a:ext cx="1080" cy="3172680"/>
            </a:xfrm>
            <a:prstGeom prst="straightConnector1">
              <a:avLst/>
            </a:prstGeom>
            <a:ln cap="sq" w="22320">
              <a:solidFill>
                <a:srgbClr val="000000"/>
              </a:solidFill>
              <a:miter/>
              <a:tailEnd len="lg" type="stealth" w="lg"/>
            </a:ln>
          </p:spPr>
        </p:cxnSp>
        <p:cxnSp>
          <p:nvCxnSpPr>
            <p:cNvPr id="46" name="Gerade Verbindung mit Pfeil 6"/>
            <p:cNvCxnSpPr/>
            <p:nvPr/>
          </p:nvCxnSpPr>
          <p:spPr>
            <a:xfrm>
              <a:off x="1976400" y="6544800"/>
              <a:ext cx="3183840" cy="1080"/>
            </a:xfrm>
            <a:prstGeom prst="straightConnector1">
              <a:avLst/>
            </a:prstGeom>
            <a:ln cap="sq" w="22320">
              <a:solidFill>
                <a:srgbClr val="000000"/>
              </a:solidFill>
              <a:miter/>
              <a:tailEnd len="lg" type="stealth" w="lg"/>
            </a:ln>
          </p:spPr>
        </p:cxnSp>
        <p:sp>
          <p:nvSpPr>
            <p:cNvPr id="47" name="Textfeld 17"/>
            <p:cNvSpPr/>
            <p:nvPr/>
          </p:nvSpPr>
          <p:spPr>
            <a:xfrm>
              <a:off x="3070080" y="6561000"/>
              <a:ext cx="995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GPNM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feld 18"/>
            <p:cNvSpPr/>
            <p:nvPr/>
          </p:nvSpPr>
          <p:spPr>
            <a:xfrm rot="16200000">
              <a:off x="1016280" y="4809600"/>
              <a:ext cx="1668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% of Ma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feld 19"/>
            <p:cNvSpPr/>
            <p:nvPr/>
          </p:nvSpPr>
          <p:spPr>
            <a:xfrm>
              <a:off x="2139840" y="3376440"/>
              <a:ext cx="1346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matinib + CI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feld 37"/>
            <p:cNvSpPr/>
            <p:nvPr/>
          </p:nvSpPr>
          <p:spPr>
            <a:xfrm>
              <a:off x="3025800" y="3608280"/>
              <a:ext cx="4968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7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feld 19"/>
            <p:cNvSpPr/>
            <p:nvPr/>
          </p:nvSpPr>
          <p:spPr>
            <a:xfrm>
              <a:off x="1990800" y="4957920"/>
              <a:ext cx="1663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imatinib + MITF-inh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feld 37"/>
            <p:cNvSpPr/>
            <p:nvPr/>
          </p:nvSpPr>
          <p:spPr>
            <a:xfrm>
              <a:off x="3111480" y="5192640"/>
              <a:ext cx="368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3" name="Picture 9" descr=""/>
            <p:cNvPicPr/>
            <p:nvPr/>
          </p:nvPicPr>
          <p:blipFill>
            <a:blip r:embed="rId3"/>
            <a:srcRect l="10306" t="6935" r="10306" b="25601"/>
            <a:stretch/>
          </p:blipFill>
          <p:spPr>
            <a:xfrm>
              <a:off x="3630600" y="5165640"/>
              <a:ext cx="1384200" cy="1306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8" descr=""/>
            <p:cNvPicPr/>
            <p:nvPr/>
          </p:nvPicPr>
          <p:blipFill>
            <a:blip r:embed="rId4"/>
            <a:srcRect l="10135" t="7969" r="8657" b="25732"/>
            <a:stretch/>
          </p:blipFill>
          <p:spPr>
            <a:xfrm>
              <a:off x="3630600" y="3608280"/>
              <a:ext cx="1384200" cy="1285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Textfeld 19"/>
            <p:cNvSpPr/>
            <p:nvPr/>
          </p:nvSpPr>
          <p:spPr>
            <a:xfrm>
              <a:off x="3645000" y="3376440"/>
              <a:ext cx="146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ilotinib + CI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feld 37"/>
            <p:cNvSpPr/>
            <p:nvPr/>
          </p:nvSpPr>
          <p:spPr>
            <a:xfrm>
              <a:off x="4683240" y="3608280"/>
              <a:ext cx="368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89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feld 19"/>
            <p:cNvSpPr/>
            <p:nvPr/>
          </p:nvSpPr>
          <p:spPr>
            <a:xfrm>
              <a:off x="3543480" y="4957920"/>
              <a:ext cx="1663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nilotinib + MITF-inh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feld 37"/>
            <p:cNvSpPr/>
            <p:nvPr/>
          </p:nvSpPr>
          <p:spPr>
            <a:xfrm>
              <a:off x="4673520" y="5207040"/>
              <a:ext cx="368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27T12:51:59Z</dcterms:created>
  <dc:creator>IMGrueF1</dc:creator>
  <dc:description/>
  <dc:language>en-US</dc:language>
  <cp:lastModifiedBy>IMGrueF1</cp:lastModifiedBy>
  <dcterms:modified xsi:type="dcterms:W3CDTF">2015-03-09T13:14:42Z</dcterms:modified>
  <cp:revision>65</cp:revision>
  <dc:subject/>
  <dc:title>Folie 1</dc:title>
</cp:coreProperties>
</file>